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56" r:id="rId2"/>
    <p:sldId id="257" r:id="rId3"/>
    <p:sldId id="258" r:id="rId4"/>
    <p:sldId id="259" r:id="rId5"/>
    <p:sldId id="260" r:id="rId6"/>
    <p:sldId id="261" r:id="rId7"/>
    <p:sldId id="265" r:id="rId8"/>
    <p:sldId id="266" r:id="rId9"/>
    <p:sldId id="264" r:id="rId10"/>
    <p:sldId id="263" r:id="rId11"/>
    <p:sldId id="267" r:id="rId1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203" autoAdjust="0"/>
    <p:restoredTop sz="94660"/>
  </p:normalViewPr>
  <p:slideViewPr>
    <p:cSldViewPr snapToGrid="0">
      <p:cViewPr varScale="1">
        <p:scale>
          <a:sx n="61" d="100"/>
          <a:sy n="61" d="100"/>
        </p:scale>
        <p:origin x="39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7075DD-E0FF-44A9-846C-1596D21CD188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54400C-4274-4351-B416-1C5170F3AC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476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54400C-4274-4351-B416-1C5170F3AC3F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447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54400C-4274-4351-B416-1C5170F3AC3F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0588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9826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253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6581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544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516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169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7675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1435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49697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0671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0646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8CA8D-692B-4FA0-B1EF-D16E2A4E6A17}" type="datetimeFigureOut">
              <a:rPr lang="zh-CN" altLang="en-US" smtClean="0"/>
              <a:t>2024/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A65C5-922E-4C7B-B190-E2A77759649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792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6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7744" y="1355059"/>
            <a:ext cx="4432936" cy="3082949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3371177" y="238706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143569" y="239064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0537" y="4932650"/>
            <a:ext cx="4705360" cy="2620218"/>
          </a:xfrm>
          <a:prstGeom prst="rect">
            <a:avLst/>
          </a:prstGeom>
        </p:spPr>
      </p:pic>
      <p:sp>
        <p:nvSpPr>
          <p:cNvPr id="36" name="文本框 35"/>
          <p:cNvSpPr txBox="1"/>
          <p:nvPr/>
        </p:nvSpPr>
        <p:spPr>
          <a:xfrm>
            <a:off x="4811776" y="61232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4610480" y="612497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4407285" y="612821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4196775" y="61314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3998717" y="61232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3810668" y="61232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3622161" y="61232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3413657" y="61314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81940" y="670798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81940" y="129540"/>
            <a:ext cx="40735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Uncropped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western blot images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306786" y="1082802"/>
            <a:ext cx="2326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EBP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306786" y="4567740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81940" y="7901508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f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3216470" y="2412675"/>
            <a:ext cx="84850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4147723" y="2412675"/>
            <a:ext cx="84850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3469957" y="208358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282757" y="2083587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A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607209" y="238333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827460" y="238340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064978" y="237317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291103" y="237317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527724" y="237481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753939" y="236911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3527630" y="6162323"/>
            <a:ext cx="66914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4330920" y="6162323"/>
            <a:ext cx="68460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3710862" y="583295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392301" y="5845017"/>
            <a:ext cx="4443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A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图片 4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456" y="8667668"/>
            <a:ext cx="5131463" cy="2870749"/>
          </a:xfrm>
          <a:prstGeom prst="rect">
            <a:avLst/>
          </a:prstGeom>
        </p:spPr>
      </p:pic>
      <p:sp>
        <p:nvSpPr>
          <p:cNvPr id="47" name="文本框 46"/>
          <p:cNvSpPr txBox="1"/>
          <p:nvPr/>
        </p:nvSpPr>
        <p:spPr>
          <a:xfrm>
            <a:off x="2364459" y="8367515"/>
            <a:ext cx="23263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EBP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4207004" y="101068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3931032" y="1011316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3773791" y="1011316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3589371" y="1011135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3296469" y="1010939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3045807" y="1010728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2909887" y="1010569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2714243" y="1010887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2843336" y="10147266"/>
            <a:ext cx="66914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>
            <a:off x="3697426" y="10147266"/>
            <a:ext cx="68460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>
            <a:off x="2799043" y="9862644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3763617" y="9847450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1780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352" y="1027427"/>
            <a:ext cx="3905795" cy="3962953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2159462" y="699942"/>
            <a:ext cx="2672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llagen I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8878294">
            <a:off x="3647768" y="1970644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 rot="18797625">
            <a:off x="3829046" y="1884702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9462" y="5528817"/>
            <a:ext cx="2505425" cy="2905530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 rot="18878294">
            <a:off x="2868861" y="6057622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/>
          <p:cNvSpPr/>
          <p:nvPr/>
        </p:nvSpPr>
        <p:spPr>
          <a:xfrm rot="18797625">
            <a:off x="3394117" y="5949900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 rot="18797625">
            <a:off x="3050139" y="5971680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200759" y="511972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1518" y="8884507"/>
            <a:ext cx="3248478" cy="2915057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2200759" y="8540030"/>
            <a:ext cx="2672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DAMTS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 rot="18878294">
            <a:off x="2684689" y="9927411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 rot="18797625">
            <a:off x="3209945" y="9819689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 rot="18797625">
            <a:off x="2865967" y="9841469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 rot="18797625">
            <a:off x="4183725" y="1875349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0333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0181" y="1101973"/>
            <a:ext cx="2505425" cy="2934109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280181" y="631041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 rot="18878294">
            <a:off x="2742748" y="1673946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 rot="18797625">
            <a:off x="3268004" y="1566224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 rot="18797625">
            <a:off x="2924026" y="1588004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726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6634" y="894298"/>
            <a:ext cx="4343122" cy="3067856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356831" y="253057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4099909" y="253692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942668" y="253692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739198" y="254147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452646" y="252681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227384" y="253105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091464" y="252946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895820" y="253264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3024913" y="2571033"/>
            <a:ext cx="66914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3847253" y="2571033"/>
            <a:ext cx="68460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980620" y="2286411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913444" y="2271217"/>
            <a:ext cx="595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81940" y="156442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2f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340172" y="537039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81940" y="4057853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990" y="4867751"/>
            <a:ext cx="3240408" cy="3373576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6618" y="8568821"/>
            <a:ext cx="3429479" cy="3610479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 rot="18525214">
            <a:off x="2978705" y="582205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 rot="18797625">
            <a:off x="3267681" y="5874285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 rot="18797625">
            <a:off x="3708410" y="5454842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 rot="18797625">
            <a:off x="3435978" y="5590565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375518" y="4457033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MMP1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2274525" y="8260376"/>
            <a:ext cx="2672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DAMTS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 rot="18525214">
            <a:off x="2956442" y="10178498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 rot="18797625">
            <a:off x="3235894" y="10230726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 rot="18797625">
            <a:off x="3619469" y="981128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/>
          <p:cNvSpPr/>
          <p:nvPr/>
        </p:nvSpPr>
        <p:spPr>
          <a:xfrm rot="18797625">
            <a:off x="3327988" y="9947006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2060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430475" y="403381"/>
            <a:ext cx="2557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greca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371" y="888801"/>
            <a:ext cx="3348343" cy="318092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340172" y="4085784"/>
            <a:ext cx="269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ollagen I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9371" y="4495028"/>
            <a:ext cx="3706154" cy="346814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5518" y="8134907"/>
            <a:ext cx="3019846" cy="3972479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430475" y="7844984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 rot="18525214">
            <a:off x="3267592" y="9772098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 rot="18797625">
            <a:off x="3547044" y="9824326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 rot="18797625">
            <a:off x="3905219" y="940488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 rot="18797625">
            <a:off x="3639138" y="9540606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 rot="18525214">
            <a:off x="2880622" y="5409961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8797625">
            <a:off x="3160074" y="5462189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 rot="18797625">
            <a:off x="3543649" y="5042746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 rot="18797625">
            <a:off x="3252168" y="5178469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 rot="18525214">
            <a:off x="3108231" y="145825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 rot="18797625">
            <a:off x="3387683" y="1510485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 rot="18797625">
            <a:off x="3745858" y="1091042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 rot="18797625">
            <a:off x="3479777" y="1226765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07767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4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1445" y="933476"/>
            <a:ext cx="3209772" cy="345787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203087" y="559055"/>
            <a:ext cx="2672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DAMTS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18525214">
            <a:off x="2810392" y="2410855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 rot="18797625">
            <a:off x="3089844" y="2463083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 rot="18797625">
            <a:off x="3448019" y="2043640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 rot="18797625">
            <a:off x="3181938" y="2179363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2438" y="4789557"/>
            <a:ext cx="3556346" cy="31544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2341668" y="4475635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 rot="18525214">
            <a:off x="3462589" y="5591264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8797625">
            <a:off x="3742041" y="5643492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 rot="18797625">
            <a:off x="4081166" y="5290725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 rot="18797625">
            <a:off x="3834135" y="5359772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94764" y="827888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6398" y="9066982"/>
            <a:ext cx="3048425" cy="2943636"/>
          </a:xfrm>
          <a:prstGeom prst="rect">
            <a:avLst/>
          </a:prstGeom>
        </p:spPr>
      </p:pic>
      <p:sp>
        <p:nvSpPr>
          <p:cNvPr id="21" name="文本框 20"/>
          <p:cNvSpPr txBox="1"/>
          <p:nvPr/>
        </p:nvSpPr>
        <p:spPr>
          <a:xfrm>
            <a:off x="2060345" y="8669295"/>
            <a:ext cx="31005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p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α (Ser32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 rot="18525214">
            <a:off x="2717614" y="9972508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 rot="18797625">
            <a:off x="2997066" y="10024736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 rot="18797625">
            <a:off x="3355241" y="960529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 rot="18797625">
            <a:off x="3089160" y="9741016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1440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81940" y="156442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374307" y="587754"/>
            <a:ext cx="2061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971" y="1050738"/>
            <a:ext cx="3381847" cy="3029373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 rot="18525214">
            <a:off x="2983648" y="1745698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 rot="18797625">
            <a:off x="3263100" y="1797926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8797625">
            <a:off x="3621275" y="137848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 rot="18797625">
            <a:off x="3355194" y="1514206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985386" y="4337903"/>
            <a:ext cx="3147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p-p65 (Ser536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2732" y="4750233"/>
            <a:ext cx="3372321" cy="3591426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 rot="18525214">
            <a:off x="3234574" y="6187071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 rot="18797625">
            <a:off x="3514026" y="6239299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 rot="18797625">
            <a:off x="3872201" y="5819856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 rot="18797625">
            <a:off x="3606120" y="5955579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628" y="9001835"/>
            <a:ext cx="4201111" cy="2476846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2500529" y="8516856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p6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 rot="18525214">
            <a:off x="3591951" y="9531105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/>
          <p:cNvSpPr/>
          <p:nvPr/>
        </p:nvSpPr>
        <p:spPr>
          <a:xfrm rot="18797625">
            <a:off x="3871403" y="9583333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/>
          <p:cNvSpPr/>
          <p:nvPr/>
        </p:nvSpPr>
        <p:spPr>
          <a:xfrm rot="18797625">
            <a:off x="4229578" y="9163890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 rot="18797625">
            <a:off x="3963497" y="9299613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21686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5121" y="929557"/>
            <a:ext cx="3620005" cy="2715004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281940" y="156442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273136" y="552124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 rot="18525214">
            <a:off x="2985712" y="1714418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 rot="18797625">
            <a:off x="3265164" y="1766646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 rot="18797625">
            <a:off x="3623339" y="134720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 rot="18797625">
            <a:off x="3357258" y="1482926"/>
            <a:ext cx="14269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81940" y="3755759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0778" y="4869085"/>
            <a:ext cx="1897246" cy="2474669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1076" y="4869085"/>
            <a:ext cx="1896212" cy="269732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099" y="8519137"/>
            <a:ext cx="1678753" cy="2177701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3505" y="8541204"/>
            <a:ext cx="2258134" cy="1871716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9182" y="8519137"/>
            <a:ext cx="1995879" cy="2312466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1116230" y="4251393"/>
            <a:ext cx="23263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EBP1</a:t>
            </a:r>
          </a:p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or I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624736" y="4251395"/>
            <a:ext cx="20617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or I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81304" y="7850710"/>
            <a:ext cx="23263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EBP1</a:t>
            </a:r>
          </a:p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or Inpu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417490" y="7848011"/>
            <a:ext cx="20617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or Inpu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494905" y="7848010"/>
            <a:ext cx="241604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</a:p>
          <a:p>
            <a:pPr algn="ct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for Input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 rot="18525214">
            <a:off x="1966381" y="5365810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/>
          <p:cNvSpPr/>
          <p:nvPr/>
        </p:nvSpPr>
        <p:spPr>
          <a:xfrm rot="18797625">
            <a:off x="2245833" y="5418038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 rot="18525214">
            <a:off x="4411093" y="5599083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 rot="18797625">
            <a:off x="4690545" y="5651311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 rot="18525214">
            <a:off x="1018162" y="9220450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/>
          <p:cNvSpPr/>
          <p:nvPr/>
        </p:nvSpPr>
        <p:spPr>
          <a:xfrm rot="18797625">
            <a:off x="1297614" y="9272678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 rot="18525214">
            <a:off x="3432553" y="8978720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 rot="18797625">
            <a:off x="3712005" y="9030948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 rot="18525214">
            <a:off x="5043147" y="9212313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 rot="18797625">
            <a:off x="5322599" y="9264541"/>
            <a:ext cx="5950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-1β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02351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5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15" y="840753"/>
            <a:ext cx="2974388" cy="336548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623" y="840753"/>
            <a:ext cx="3093752" cy="3450352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1590041" y="295192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314353" y="29607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1422057" y="2928439"/>
            <a:ext cx="119062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1570989" y="2644868"/>
            <a:ext cx="912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1877463" y="29483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141418" y="294468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420594" y="294491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843201" y="496682"/>
            <a:ext cx="2061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3796903" y="496682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512984" y="214398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237296" y="215278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4345000" y="2120501"/>
            <a:ext cx="119062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4493932" y="1836930"/>
            <a:ext cx="9124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800406" y="214041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5064361" y="213674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343537" y="213697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649" y="4580313"/>
            <a:ext cx="3233693" cy="3531356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1327146" y="549926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051458" y="550807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1159162" y="5475787"/>
            <a:ext cx="1190625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1142994" y="5195302"/>
            <a:ext cx="12330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614568" y="54956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1878523" y="549203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2157699" y="549226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837408" y="4276443"/>
            <a:ext cx="2061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0779" y="4605713"/>
            <a:ext cx="3167776" cy="3723525"/>
          </a:xfrm>
          <a:prstGeom prst="rect">
            <a:avLst/>
          </a:prstGeom>
        </p:spPr>
      </p:pic>
      <p:sp>
        <p:nvSpPr>
          <p:cNvPr id="36" name="文本框 35"/>
          <p:cNvSpPr txBox="1"/>
          <p:nvPr/>
        </p:nvSpPr>
        <p:spPr>
          <a:xfrm>
            <a:off x="3876435" y="4276443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4953810" y="619048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4706697" y="619928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4821014" y="6220527"/>
            <a:ext cx="1015698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>
            <a:off x="4743057" y="5951274"/>
            <a:ext cx="12330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5219007" y="618691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5463912" y="618325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5666888" y="618347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294764" y="8317043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图片 44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533" y="9070962"/>
            <a:ext cx="3671588" cy="2845267"/>
          </a:xfrm>
          <a:prstGeom prst="rect">
            <a:avLst/>
          </a:prstGeom>
        </p:spPr>
      </p:pic>
      <p:sp>
        <p:nvSpPr>
          <p:cNvPr id="46" name="文本框 45"/>
          <p:cNvSpPr txBox="1"/>
          <p:nvPr/>
        </p:nvSpPr>
        <p:spPr>
          <a:xfrm>
            <a:off x="1011171" y="8716548"/>
            <a:ext cx="2061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 rot="18878294">
            <a:off x="1865735" y="9712145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/>
          <p:cNvSpPr/>
          <p:nvPr/>
        </p:nvSpPr>
        <p:spPr>
          <a:xfrm rot="18797625">
            <a:off x="2403540" y="9626255"/>
            <a:ext cx="10166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zh-CN" sz="14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IκB</a:t>
            </a:r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矩形 48"/>
          <p:cNvSpPr/>
          <p:nvPr/>
        </p:nvSpPr>
        <p:spPr>
          <a:xfrm rot="18797625">
            <a:off x="2126263" y="9626255"/>
            <a:ext cx="9124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zh-CN" sz="14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633" y="9141324"/>
            <a:ext cx="2858033" cy="3000047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4042370" y="8716573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 rot="18878294">
            <a:off x="4721529" y="1014972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/>
          <p:cNvSpPr/>
          <p:nvPr/>
        </p:nvSpPr>
        <p:spPr>
          <a:xfrm rot="18797625">
            <a:off x="5259334" y="10063837"/>
            <a:ext cx="101662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zh-CN" sz="14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IκB</a:t>
            </a:r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/>
          <p:cNvSpPr/>
          <p:nvPr/>
        </p:nvSpPr>
        <p:spPr>
          <a:xfrm rot="18797625">
            <a:off x="4982057" y="10078126"/>
            <a:ext cx="9124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-</a:t>
            </a:r>
            <a:r>
              <a:rPr lang="en-US" altLang="zh-CN" sz="1400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4978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2439" y="1161768"/>
            <a:ext cx="3734321" cy="2772162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 rot="18878294">
            <a:off x="3356926" y="1680045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 rot="18797625">
            <a:off x="3981242" y="1572323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 rot="18797625">
            <a:off x="3599164" y="159410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435014" y="738203"/>
            <a:ext cx="2061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IκB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4257" y="4432383"/>
            <a:ext cx="2549694" cy="3612067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 rot="18878294">
            <a:off x="2982869" y="5507742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/>
          <p:cNvSpPr/>
          <p:nvPr/>
        </p:nvSpPr>
        <p:spPr>
          <a:xfrm rot="18797625">
            <a:off x="3508125" y="5400020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 rot="18797625">
            <a:off x="3164147" y="5421800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024516" y="4029834"/>
            <a:ext cx="3147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p-p65 (Ser536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7274" y="8489779"/>
            <a:ext cx="3004257" cy="3574031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 rot="18878294">
            <a:off x="3273747" y="9054161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矩形 27"/>
          <p:cNvSpPr/>
          <p:nvPr/>
        </p:nvSpPr>
        <p:spPr>
          <a:xfrm rot="18797625">
            <a:off x="3799003" y="8946439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 rot="18797625">
            <a:off x="3455025" y="8968219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2668663" y="8134295"/>
            <a:ext cx="19800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p6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05673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81940" y="156442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3099" y="960987"/>
            <a:ext cx="3229576" cy="3628289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2269864" y="628933"/>
            <a:ext cx="2416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 rot="18878294">
            <a:off x="2881269" y="1733979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 rot="18797625">
            <a:off x="3406525" y="1626257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 rot="18797625">
            <a:off x="3062547" y="1648037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8354" y="5006173"/>
            <a:ext cx="3641112" cy="3175496"/>
          </a:xfrm>
          <a:prstGeom prst="rect">
            <a:avLst/>
          </a:prstGeom>
        </p:spPr>
      </p:pic>
      <p:sp>
        <p:nvSpPr>
          <p:cNvPr id="27" name="文本框 26"/>
          <p:cNvSpPr txBox="1"/>
          <p:nvPr/>
        </p:nvSpPr>
        <p:spPr>
          <a:xfrm>
            <a:off x="2282689" y="4639057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MMP1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 rot="18878294">
            <a:off x="3639011" y="5652823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 rot="18797625">
            <a:off x="4164267" y="5545101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 rot="18797625">
            <a:off x="3820289" y="5566881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9309" y="8663509"/>
            <a:ext cx="3260141" cy="3497402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2236855" y="8251309"/>
            <a:ext cx="2672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The bands of ADAMTS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 rot="18878294">
            <a:off x="3285590" y="9751405"/>
            <a:ext cx="14269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</a:t>
            </a:r>
            <a:r>
              <a:rPr lang="en-US" altLang="zh-CN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NC</a:t>
            </a:r>
            <a:endParaRPr lang="zh-CN" altLang="en-US" sz="11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矩形 33"/>
          <p:cNvSpPr/>
          <p:nvPr/>
        </p:nvSpPr>
        <p:spPr>
          <a:xfrm rot="18797625">
            <a:off x="3810846" y="9643683"/>
            <a:ext cx="17475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</a:p>
          <a:p>
            <a:r>
              <a:rPr lang="en-US" altLang="zh-CN" sz="14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Ad-shIκBα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矩形 34"/>
          <p:cNvSpPr/>
          <p:nvPr/>
        </p:nvSpPr>
        <p:spPr>
          <a:xfrm rot="18797625">
            <a:off x="3466868" y="9665463"/>
            <a:ext cx="17475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L-1β+Ad-shAEBP1</a:t>
            </a:r>
            <a:endParaRPr lang="zh-CN" altLang="en-US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1318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</TotalTime>
  <Words>385</Words>
  <PresentationFormat>宽屏</PresentationFormat>
  <Paragraphs>229</Paragraphs>
  <Slides>11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8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15T09:22:44Z</dcterms:created>
  <dcterms:modified xsi:type="dcterms:W3CDTF">2024-01-23T02:08:39Z</dcterms:modified>
</cp:coreProperties>
</file>